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05638" cy="92916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378CEB-D005-4E8E-A746-236FBD2C0A0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6403DA-3DA8-459A-8CA0-172DE65321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0CAB8C-C9FB-4526-AC0C-D054F76502A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0432E2-9364-4916-9C5A-AECF25FDFB7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479B5C-3D64-4F8E-BA85-59BFC013E6A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C15CBB-ED0F-4725-9FBA-E021770E63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AD5637-7170-4EC0-BAEE-71B6BF898F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44C2A0-FB67-4292-9543-4B73D537F4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894BD8-F978-4D6C-B926-841E28D0936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B78B24-481F-4EF8-913A-6FD4659C5E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A14614-5740-44EE-8D3B-80DA5B2CC9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5C64CD-9FCB-414B-A0D6-5BD746A748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4C6405E-6454-4B3D-AC0F-837F74A5D3FE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628200" y="714240"/>
            <a:ext cx="1677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Fig. S6   Spätzle-related protein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2057400" y="3314880"/>
            <a:ext cx="2868120" cy="2396880"/>
            <a:chOff x="2057400" y="3314880"/>
            <a:chExt cx="2868120" cy="2396880"/>
          </a:xfrm>
        </p:grpSpPr>
        <p:grpSp>
          <p:nvGrpSpPr>
            <p:cNvPr id="43" name=""/>
            <p:cNvGrpSpPr/>
            <p:nvPr/>
          </p:nvGrpSpPr>
          <p:grpSpPr>
            <a:xfrm>
              <a:off x="2423880" y="3446280"/>
              <a:ext cx="2111040" cy="2009520"/>
              <a:chOff x="2423880" y="3446280"/>
              <a:chExt cx="2111040" cy="2009520"/>
            </a:xfrm>
          </p:grpSpPr>
          <p:sp>
            <p:nvSpPr>
              <p:cNvPr id="44" name=""/>
              <p:cNvSpPr/>
              <p:nvPr/>
            </p:nvSpPr>
            <p:spPr>
              <a:xfrm>
                <a:off x="3288960" y="3446280"/>
                <a:ext cx="35280" cy="805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2423880" y="4273200"/>
                <a:ext cx="670320" cy="10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2522520" y="3990240"/>
                <a:ext cx="569880" cy="382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3092760" y="4372560"/>
                <a:ext cx="68760" cy="24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 flipV="1">
                <a:off x="2423880" y="4401000"/>
                <a:ext cx="739440" cy="167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3163320" y="4399560"/>
                <a:ext cx="221040" cy="38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920" bIns="-7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2648520" y="3661200"/>
                <a:ext cx="713160" cy="714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3027240" y="3636360"/>
                <a:ext cx="295200" cy="611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3324240" y="4251960"/>
                <a:ext cx="38880" cy="129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3363480" y="4381560"/>
                <a:ext cx="24840" cy="42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 flipH="1">
                <a:off x="3407400" y="3501360"/>
                <a:ext cx="192600" cy="889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 flipH="1">
                <a:off x="3421800" y="3641760"/>
                <a:ext cx="442080" cy="732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 flipH="1">
                <a:off x="3418200" y="3760920"/>
                <a:ext cx="762480" cy="615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 flipH="1">
                <a:off x="3411000" y="4376160"/>
                <a:ext cx="8640" cy="10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360" bIns="-36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 flipH="1">
                <a:off x="3393360" y="4392360"/>
                <a:ext cx="12240" cy="26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520" bIns="-20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 flipH="1">
                <a:off x="3384360" y="4066920"/>
                <a:ext cx="927000" cy="355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 flipH="1">
                <a:off x="3386520" y="4422600"/>
                <a:ext cx="3600" cy="15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3386520" y="4438440"/>
                <a:ext cx="10440" cy="19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360" bIns="-27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 flipH="1">
                <a:off x="3352320" y="4457880"/>
                <a:ext cx="44280" cy="92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360" bIns="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3396960" y="4456440"/>
                <a:ext cx="6192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 flipH="1">
                <a:off x="3018240" y="4550400"/>
                <a:ext cx="332640" cy="227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 flipH="1">
                <a:off x="2915280" y="4778280"/>
                <a:ext cx="10260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 flipH="1">
                <a:off x="2545200" y="4808520"/>
                <a:ext cx="369720" cy="42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" bIns="-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 flipH="1">
                <a:off x="2655000" y="4808520"/>
                <a:ext cx="261720" cy="222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 flipH="1">
                <a:off x="2802240" y="4780080"/>
                <a:ext cx="215640" cy="428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3352680" y="4550400"/>
                <a:ext cx="5040" cy="250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3359880" y="4804920"/>
                <a:ext cx="226440" cy="641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 flipH="1">
                <a:off x="3334680" y="4804920"/>
                <a:ext cx="22680" cy="60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680" bIns="13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 flipH="1">
                <a:off x="3037680" y="4867200"/>
                <a:ext cx="297360" cy="492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 flipH="1">
                <a:off x="3296160" y="4869000"/>
                <a:ext cx="40320" cy="586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3906720" y="5007600"/>
                <a:ext cx="242280" cy="284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3908520" y="5007600"/>
                <a:ext cx="6840" cy="373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 flipH="1" flipV="1">
                <a:off x="3889080" y="4943160"/>
                <a:ext cx="19440" cy="63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920" bIns="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3887280" y="4947120"/>
                <a:ext cx="415800" cy="138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 flipH="1" flipV="1">
                <a:off x="3456720" y="4486680"/>
                <a:ext cx="431640" cy="458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3457080" y="4486680"/>
                <a:ext cx="433440" cy="56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9720" bIns="9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3889080" y="4543560"/>
                <a:ext cx="619200" cy="21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 flipV="1">
                <a:off x="3887280" y="4381200"/>
                <a:ext cx="647640" cy="161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2" name=""/>
            <p:cNvSpPr/>
            <p:nvPr/>
          </p:nvSpPr>
          <p:spPr>
            <a:xfrm>
              <a:off x="3495600" y="3379680"/>
              <a:ext cx="326520" cy="9828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c Spz1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3071520" y="3314880"/>
              <a:ext cx="326880" cy="9828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c Spz2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2333520" y="3882960"/>
              <a:ext cx="327960" cy="90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0000"/>
                  </a:solidFill>
                  <a:latin typeface="Arial"/>
                  <a:ea typeface="宋体"/>
                </a:rPr>
                <a:t>Ag Spz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2435040" y="3549600"/>
              <a:ext cx="347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Bm Spz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2768400" y="3483000"/>
              <a:ext cx="501120" cy="9180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m GB15688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2076120" y="4156200"/>
              <a:ext cx="371160" cy="183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Dm Spz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/CG997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2057400" y="4524480"/>
              <a:ext cx="326880" cy="9792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c Spz5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2180880" y="4813200"/>
              <a:ext cx="326880" cy="9828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c Spz3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2342880" y="5011560"/>
              <a:ext cx="312480" cy="82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0000"/>
                  </a:solidFill>
                  <a:latin typeface="Arial"/>
                  <a:ea typeface="宋体"/>
                </a:rPr>
                <a:t>Ag Spz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2463480" y="5168880"/>
              <a:ext cx="356760" cy="18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Dm Spz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/CG710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2833560" y="5380200"/>
              <a:ext cx="317160" cy="88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0000"/>
                  </a:solidFill>
                  <a:latin typeface="Arial"/>
                  <a:ea typeface="宋体"/>
                </a:rPr>
                <a:t>Ag Spz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3093840" y="5508720"/>
              <a:ext cx="363240" cy="183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Dm Spz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/CG1492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3476520" y="5486400"/>
              <a:ext cx="326520" cy="9792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c Spz4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3828960" y="5373720"/>
              <a:ext cx="307440" cy="9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0000"/>
                  </a:solidFill>
                  <a:latin typeface="Arial"/>
                  <a:ea typeface="宋体"/>
                </a:rPr>
                <a:t>Ag Spz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4159080" y="5295960"/>
              <a:ext cx="369360" cy="183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Dm Spz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/CG919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4333680" y="5070600"/>
              <a:ext cx="329760" cy="9792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c Spz6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4527360" y="4719600"/>
              <a:ext cx="321840" cy="90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0000"/>
                  </a:solidFill>
                  <a:latin typeface="Arial"/>
                  <a:ea typeface="宋体"/>
                </a:rPr>
                <a:t>Ag Spz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4552560" y="4280040"/>
              <a:ext cx="372960" cy="183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Dm Spz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/CG3224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4350960" y="4000320"/>
              <a:ext cx="326880" cy="9828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c Spz7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4200120" y="3649680"/>
              <a:ext cx="333360" cy="183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Dm Spz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/CG613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3708000" y="3525840"/>
              <a:ext cx="501480" cy="9324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m GB13503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4587480" y="5560920"/>
              <a:ext cx="14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 rot="15237000">
              <a:off x="3330000" y="4213080"/>
              <a:ext cx="41040" cy="4716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 rot="7389600">
              <a:off x="3287880" y="4827960"/>
              <a:ext cx="41040" cy="4896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240" bIns="-302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 flipH="1" flipV="1" rot="7356600">
              <a:off x="3358800" y="4539600"/>
              <a:ext cx="40680" cy="4752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 rot="15390000">
              <a:off x="3364200" y="4777560"/>
              <a:ext cx="42480" cy="4716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 rot="12341400">
              <a:off x="3160440" y="4346280"/>
              <a:ext cx="42480" cy="4860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600" bIns="-306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 rot="11990400">
              <a:off x="3088800" y="4324320"/>
              <a:ext cx="42480" cy="4896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240" bIns="-302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 rot="18482400">
              <a:off x="3021120" y="4774320"/>
              <a:ext cx="42480" cy="4716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 flipH="1" flipV="1" rot="16200000">
              <a:off x="3857400" y="4994280"/>
              <a:ext cx="42480" cy="4896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240" bIns="-302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 rot="13063200">
              <a:off x="3885480" y="4899960"/>
              <a:ext cx="41040" cy="4716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 rot="11193000">
              <a:off x="3861720" y="4485600"/>
              <a:ext cx="42480" cy="4716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4527360" y="5711760"/>
              <a:ext cx="2347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 rot="12067800">
              <a:off x="3457080" y="4438440"/>
              <a:ext cx="40680" cy="4716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2490480" y="4949640"/>
              <a:ext cx="37800" cy="47520"/>
            </a:xfrm>
            <a:prstGeom prst="line">
              <a:avLst/>
            </a:prstGeom>
            <a:ln w="19080">
              <a:solidFill>
                <a:srgbClr val="0066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2604960" y="5095800"/>
              <a:ext cx="85320" cy="72720"/>
            </a:xfrm>
            <a:prstGeom prst="line">
              <a:avLst/>
            </a:prstGeom>
            <a:ln w="19080">
              <a:solidFill>
                <a:srgbClr val="0066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3090600" y="5473800"/>
              <a:ext cx="114120" cy="23400"/>
            </a:xfrm>
            <a:prstGeom prst="line">
              <a:avLst/>
            </a:prstGeom>
            <a:ln w="19080">
              <a:solidFill>
                <a:srgbClr val="0066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 flipV="1">
              <a:off x="3381120" y="5502240"/>
              <a:ext cx="80640" cy="4320"/>
            </a:xfrm>
            <a:prstGeom prst="line">
              <a:avLst/>
            </a:prstGeom>
            <a:ln w="19080">
              <a:solidFill>
                <a:srgbClr val="0066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480" bIns="-42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 flipV="1">
              <a:off x="4035240" y="5354640"/>
              <a:ext cx="78840" cy="18720"/>
            </a:xfrm>
            <a:prstGeom prst="line">
              <a:avLst/>
            </a:prstGeom>
            <a:ln w="19080">
              <a:solidFill>
                <a:srgbClr val="0066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 flipV="1">
              <a:off x="4281120" y="5197320"/>
              <a:ext cx="115560" cy="85680"/>
            </a:xfrm>
            <a:prstGeom prst="line">
              <a:avLst/>
            </a:prstGeom>
            <a:ln w="19080">
              <a:solidFill>
                <a:srgbClr val="0066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 flipH="1">
              <a:off x="4628880" y="4497480"/>
              <a:ext cx="34560" cy="199440"/>
            </a:xfrm>
            <a:prstGeom prst="line">
              <a:avLst/>
            </a:prstGeom>
            <a:ln w="19080">
              <a:solidFill>
                <a:srgbClr val="0066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2300040" y="4362480"/>
              <a:ext cx="18720" cy="134640"/>
            </a:xfrm>
            <a:prstGeom prst="line">
              <a:avLst/>
            </a:prstGeom>
            <a:ln w="19080">
              <a:solidFill>
                <a:srgbClr val="0066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 flipV="1">
              <a:off x="2309400" y="3995280"/>
              <a:ext cx="47520" cy="137880"/>
            </a:xfrm>
            <a:prstGeom prst="line">
              <a:avLst/>
            </a:prstGeom>
            <a:ln w="19080">
              <a:solidFill>
                <a:srgbClr val="0066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 flipV="1">
              <a:off x="2985840" y="3404880"/>
              <a:ext cx="61560" cy="29880"/>
            </a:xfrm>
            <a:prstGeom prst="line">
              <a:avLst/>
            </a:prstGeom>
            <a:ln w="19080">
              <a:solidFill>
                <a:srgbClr val="0066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88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2-03T20:47:33Z</dcterms:created>
  <dc:creator>haobo</dc:creator>
  <dc:description/>
  <dc:language>en-US</dc:language>
  <cp:lastModifiedBy>Haobo Jiang</cp:lastModifiedBy>
  <dcterms:modified xsi:type="dcterms:W3CDTF">2007-08-08T18:32:17Z</dcterms:modified>
  <cp:revision>103</cp:revision>
  <dc:subject/>
  <dc:title>Slide 1</dc:title>
</cp:coreProperties>
</file>